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5" d="100"/>
          <a:sy n="105" d="100"/>
        </p:scale>
        <p:origin x="192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C8E17E-2066-4E20-A62B-7F217E15AEFD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F9649-03A1-4353-A130-59CAFCFD6A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95591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C8E17E-2066-4E20-A62B-7F217E15AEFD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F9649-03A1-4353-A130-59CAFCFD6A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56883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C8E17E-2066-4E20-A62B-7F217E15AEFD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F9649-03A1-4353-A130-59CAFCFD6A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82060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C8E17E-2066-4E20-A62B-7F217E15AEFD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F9649-03A1-4353-A130-59CAFCFD6A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15480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C8E17E-2066-4E20-A62B-7F217E15AEFD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F9649-03A1-4353-A130-59CAFCFD6A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42999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C8E17E-2066-4E20-A62B-7F217E15AEFD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F9649-03A1-4353-A130-59CAFCFD6A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77153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C8E17E-2066-4E20-A62B-7F217E15AEFD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F9649-03A1-4353-A130-59CAFCFD6A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5486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C8E17E-2066-4E20-A62B-7F217E15AEFD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F9649-03A1-4353-A130-59CAFCFD6A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60768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C8E17E-2066-4E20-A62B-7F217E15AEFD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F9649-03A1-4353-A130-59CAFCFD6A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56238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C8E17E-2066-4E20-A62B-7F217E15AEFD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F9649-03A1-4353-A130-59CAFCFD6A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75199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C8E17E-2066-4E20-A62B-7F217E15AEFD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F9649-03A1-4353-A130-59CAFCFD6A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73466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C8E17E-2066-4E20-A62B-7F217E15AEFD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5F9649-03A1-4353-A130-59CAFCFD6A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35647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tiff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28600" y="237744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2F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115" t="55082" r="36473" b="20852"/>
          <a:stretch/>
        </p:blipFill>
        <p:spPr>
          <a:xfrm>
            <a:off x="2098531" y="2693505"/>
            <a:ext cx="3485362" cy="169164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7639" t="36457" r="33589" b="37212"/>
          <a:stretch/>
        </p:blipFill>
        <p:spPr>
          <a:xfrm>
            <a:off x="2098531" y="4467441"/>
            <a:ext cx="3485362" cy="1794444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7712" t="51477" r="33891" b="23894"/>
          <a:stretch/>
        </p:blipFill>
        <p:spPr>
          <a:xfrm>
            <a:off x="2098531" y="934914"/>
            <a:ext cx="3485362" cy="1682066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2162473" y="2898449"/>
            <a:ext cx="5302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 smtClean="0">
                <a:solidFill>
                  <a:schemeClr val="bg1"/>
                </a:solidFill>
              </a:rPr>
              <a:t>kDa</a:t>
            </a:r>
            <a:endParaRPr lang="en-US" sz="1400" dirty="0">
              <a:solidFill>
                <a:schemeClr val="bg1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298175" y="3187539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298175" y="3332254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>
                <a:solidFill>
                  <a:schemeClr val="bg1"/>
                </a:solidFill>
              </a:rPr>
              <a:t>13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298175" y="3476450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305989" y="3602326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>
                <a:solidFill>
                  <a:schemeClr val="bg1"/>
                </a:solidFill>
              </a:rPr>
              <a:t>7</a:t>
            </a:r>
            <a:r>
              <a:rPr lang="de-DE" sz="1050" dirty="0" smtClean="0">
                <a:solidFill>
                  <a:schemeClr val="bg1"/>
                </a:solidFill>
              </a:rPr>
              <a:t>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313803" y="3765361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>
                <a:solidFill>
                  <a:schemeClr val="bg1"/>
                </a:solidFill>
              </a:rPr>
              <a:t>5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305857" y="4017113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>
                <a:solidFill>
                  <a:schemeClr val="bg1"/>
                </a:solidFill>
              </a:rPr>
              <a:t>3</a:t>
            </a:r>
            <a:r>
              <a:rPr lang="de-DE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305857" y="4694170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305857" y="5182508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>
                <a:solidFill>
                  <a:schemeClr val="bg1"/>
                </a:solidFill>
              </a:rPr>
              <a:t>1</a:t>
            </a:r>
            <a:r>
              <a:rPr lang="de-DE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313803" y="5588969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>
                <a:solidFill>
                  <a:schemeClr val="bg1"/>
                </a:solidFill>
              </a:rPr>
              <a:t>1</a:t>
            </a:r>
            <a:r>
              <a:rPr lang="de-DE" sz="1050" dirty="0">
                <a:solidFill>
                  <a:schemeClr val="bg1"/>
                </a:solidFill>
              </a:rPr>
              <a:t>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174880" y="3896166"/>
            <a:ext cx="9236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/>
              <a:t>IB: ß-actin</a:t>
            </a:r>
            <a:endParaRPr lang="en-US" sz="1400" dirty="0"/>
          </a:p>
        </p:txBody>
      </p:sp>
      <p:sp>
        <p:nvSpPr>
          <p:cNvPr id="19" name="TextBox 18"/>
          <p:cNvSpPr txBox="1"/>
          <p:nvPr/>
        </p:nvSpPr>
        <p:spPr>
          <a:xfrm>
            <a:off x="1174880" y="4952079"/>
            <a:ext cx="8035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/>
              <a:t>IB: GPX4</a:t>
            </a:r>
            <a:endParaRPr lang="en-US" sz="1400" dirty="0"/>
          </a:p>
        </p:txBody>
      </p:sp>
      <p:sp>
        <p:nvSpPr>
          <p:cNvPr id="20" name="TextBox 19"/>
          <p:cNvSpPr txBox="1"/>
          <p:nvPr/>
        </p:nvSpPr>
        <p:spPr>
          <a:xfrm>
            <a:off x="1170112" y="1512506"/>
            <a:ext cx="7729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/>
              <a:t>IB: LRP8</a:t>
            </a:r>
            <a:endParaRPr lang="en-US" sz="1400" dirty="0"/>
          </a:p>
        </p:txBody>
      </p:sp>
      <p:sp>
        <p:nvSpPr>
          <p:cNvPr id="21" name="TextBox 20"/>
          <p:cNvSpPr txBox="1"/>
          <p:nvPr/>
        </p:nvSpPr>
        <p:spPr>
          <a:xfrm>
            <a:off x="2189956" y="1119365"/>
            <a:ext cx="5302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err="1" smtClean="0">
                <a:solidFill>
                  <a:schemeClr val="bg1"/>
                </a:solidFill>
              </a:rPr>
              <a:t>kDa</a:t>
            </a:r>
            <a:endParaRPr lang="en-US" sz="1400" dirty="0">
              <a:solidFill>
                <a:schemeClr val="bg1"/>
              </a:solidFill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325658" y="1408455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2325658" y="1553170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>
                <a:solidFill>
                  <a:schemeClr val="bg1"/>
                </a:solidFill>
              </a:rPr>
              <a:t>13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2325658" y="1697366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333472" y="1823242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>
                <a:solidFill>
                  <a:schemeClr val="bg1"/>
                </a:solidFill>
              </a:rPr>
              <a:t>7</a:t>
            </a:r>
            <a:r>
              <a:rPr lang="de-DE" sz="1050" dirty="0" smtClean="0">
                <a:solidFill>
                  <a:schemeClr val="bg1"/>
                </a:solidFill>
              </a:rPr>
              <a:t>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2341286" y="1986277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 smtClean="0">
                <a:solidFill>
                  <a:schemeClr val="bg1"/>
                </a:solidFill>
              </a:rPr>
              <a:t>5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2333340" y="2238029"/>
            <a:ext cx="530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dirty="0">
                <a:solidFill>
                  <a:schemeClr val="bg1"/>
                </a:solidFill>
              </a:rPr>
              <a:t>3</a:t>
            </a:r>
            <a:r>
              <a:rPr lang="de-DE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8" name="Rectangle 27"/>
          <p:cNvSpPr/>
          <p:nvPr/>
        </p:nvSpPr>
        <p:spPr>
          <a:xfrm>
            <a:off x="2866302" y="3893046"/>
            <a:ext cx="1481328" cy="31089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/>
          <p:cNvSpPr/>
          <p:nvPr/>
        </p:nvSpPr>
        <p:spPr>
          <a:xfrm>
            <a:off x="2866302" y="4950518"/>
            <a:ext cx="1481328" cy="31089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/>
          <p:cNvSpPr/>
          <p:nvPr/>
        </p:nvSpPr>
        <p:spPr>
          <a:xfrm>
            <a:off x="2991580" y="1542615"/>
            <a:ext cx="1481328" cy="31089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1" name="Picture 30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081" t="36119" r="27699" b="16400"/>
          <a:stretch/>
        </p:blipFill>
        <p:spPr>
          <a:xfrm>
            <a:off x="6611097" y="1148308"/>
            <a:ext cx="5244194" cy="4656283"/>
          </a:xfrm>
          <a:prstGeom prst="rect">
            <a:avLst/>
          </a:prstGeom>
        </p:spPr>
      </p:pic>
      <p:sp>
        <p:nvSpPr>
          <p:cNvPr id="32" name="TextBox 31"/>
          <p:cNvSpPr txBox="1"/>
          <p:nvPr/>
        </p:nvSpPr>
        <p:spPr>
          <a:xfrm>
            <a:off x="4763280" y="527835"/>
            <a:ext cx="70278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solidFill>
                  <a:srgbClr val="FF0000"/>
                </a:solidFill>
              </a:rPr>
              <a:t>Red boxes always indicate the cropped areas ther were used in the figure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6588639" y="6389040"/>
            <a:ext cx="54659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Colorimetric and chemiluminecent signals were merge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255734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7</Words>
  <Application>Microsoft Office PowerPoint</Application>
  <PresentationFormat>Widescreen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Calibri Light</vt:lpstr>
      <vt:lpstr>Office Theme</vt:lpstr>
      <vt:lpstr>PowerPoint Presentation</vt:lpstr>
    </vt:vector>
  </TitlesOfParts>
  <Company>Julius-Maximilians-Universität Würzbu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iyi Chen</dc:creator>
  <cp:lastModifiedBy>Zhiyi Chen</cp:lastModifiedBy>
  <cp:revision>1</cp:revision>
  <dcterms:created xsi:type="dcterms:W3CDTF">2023-05-30T14:02:41Z</dcterms:created>
  <dcterms:modified xsi:type="dcterms:W3CDTF">2023-05-30T14:02:53Z</dcterms:modified>
</cp:coreProperties>
</file>